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7"/>
  </p:notesMasterIdLst>
  <p:sldIdLst>
    <p:sldId id="264" r:id="rId2"/>
    <p:sldId id="256" r:id="rId3"/>
    <p:sldId id="265" r:id="rId4"/>
    <p:sldId id="257" r:id="rId5"/>
    <p:sldId id="268" r:id="rId6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CC00CC"/>
    <a:srgbClr val="336699"/>
    <a:srgbClr val="F9B67F"/>
    <a:srgbClr val="F79443"/>
    <a:srgbClr val="FF8F8F"/>
    <a:srgbClr val="F8A764"/>
    <a:srgbClr val="FF6165"/>
    <a:srgbClr val="FF505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 varScale="1">
        <p:scale>
          <a:sx n="104" d="100"/>
          <a:sy n="104" d="100"/>
        </p:scale>
        <p:origin x="876" y="114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notesMaster" Target="notesMasters/notesMaster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H:\TILs\Vectra%20TILs%20on%2079_8_6\TILs%20on%20TMA79%20AQUA%20vs%20Vectra.xlsx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file:///H:\TILs\Vectra%20TILs%20on%2079_8_6\TILs%20on%20TMA79%20AQUA%20vs%20Vectra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vert="horz"/>
          <a:lstStyle/>
          <a:p>
            <a:pPr>
              <a:defRPr/>
            </a:pPr>
            <a:r>
              <a:rPr lang="en-US"/>
              <a:t>CD8: AQUA vs Vectra</a:t>
            </a:r>
          </a:p>
        </c:rich>
      </c:tx>
      <c:overlay val="0"/>
      <c:spPr>
        <a:noFill/>
        <a:ln>
          <a:noFill/>
        </a:ln>
        <a:effectLst/>
      </c:spPr>
    </c:title>
    <c:autoTitleDeleted val="0"/>
    <c:plotArea>
      <c:layout/>
      <c:scatterChart>
        <c:scatterStyle val="lineMarker"/>
        <c:varyColors val="0"/>
        <c:ser>
          <c:idx val="0"/>
          <c:order val="0"/>
          <c:spPr>
            <a:ln w="1905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tx1"/>
              </a:solidFill>
              <a:ln w="9525">
                <a:solidFill>
                  <a:schemeClr val="tx1"/>
                </a:solidFill>
              </a:ln>
              <a:effectLst/>
            </c:spPr>
          </c:marker>
          <c:trendline>
            <c:spPr>
              <a:ln w="19050" cap="rnd">
                <a:solidFill>
                  <a:schemeClr val="accent1"/>
                </a:solidFill>
                <a:prstDash val="sysDot"/>
              </a:ln>
              <a:effectLst/>
            </c:spPr>
            <c:trendlineType val="linear"/>
            <c:dispRSqr val="0"/>
            <c:dispEq val="0"/>
          </c:trendline>
          <c:trendline>
            <c:spPr>
              <a:ln w="19050" cap="rnd">
                <a:solidFill>
                  <a:schemeClr val="accent1"/>
                </a:solidFill>
                <a:prstDash val="sysDot"/>
              </a:ln>
              <a:effectLst/>
            </c:spPr>
            <c:trendlineType val="linear"/>
            <c:dispRSqr val="1"/>
            <c:dispEq val="0"/>
            <c:trendlineLbl>
              <c:layout>
                <c:manualLayout>
                  <c:x val="0.10065710820206121"/>
                  <c:y val="-0.17539924059512427"/>
                </c:manualLayout>
              </c:layout>
              <c:numFmt formatCode="General" sourceLinked="0"/>
              <c:spPr>
                <a:noFill/>
                <a:ln>
                  <a:noFill/>
                </a:ln>
                <a:effectLst/>
              </c:spPr>
              <c:txPr>
                <a:bodyPr rot="0" vert="horz"/>
                <a:lstStyle/>
                <a:p>
                  <a:pPr>
                    <a:defRPr/>
                  </a:pPr>
                  <a:endParaRPr lang="en-US"/>
                </a:p>
              </c:txPr>
            </c:trendlineLbl>
          </c:trendline>
          <c:xVal>
            <c:numRef>
              <c:f>Sheet2!$W$2:$W$156</c:f>
              <c:numCache>
                <c:formatCode>General</c:formatCode>
                <c:ptCount val="155"/>
                <c:pt idx="0">
                  <c:v>494.89150000000001</c:v>
                </c:pt>
                <c:pt idx="1">
                  <c:v>590.66030000000001</c:v>
                </c:pt>
                <c:pt idx="2">
                  <c:v>642.27919999999995</c:v>
                </c:pt>
                <c:pt idx="3">
                  <c:v>650.66749999999968</c:v>
                </c:pt>
                <c:pt idx="4">
                  <c:v>718.57709999999997</c:v>
                </c:pt>
                <c:pt idx="5">
                  <c:v>745.61829999999998</c:v>
                </c:pt>
                <c:pt idx="6">
                  <c:v>782.09360000000004</c:v>
                </c:pt>
                <c:pt idx="7">
                  <c:v>866.24829999999997</c:v>
                </c:pt>
                <c:pt idx="8">
                  <c:v>877.22670000000005</c:v>
                </c:pt>
                <c:pt idx="9">
                  <c:v>889.3981</c:v>
                </c:pt>
                <c:pt idx="10">
                  <c:v>901.61990000000003</c:v>
                </c:pt>
                <c:pt idx="11">
                  <c:v>904.51639999999998</c:v>
                </c:pt>
                <c:pt idx="12">
                  <c:v>939.17100000000005</c:v>
                </c:pt>
                <c:pt idx="13">
                  <c:v>953.55309999999997</c:v>
                </c:pt>
                <c:pt idx="14">
                  <c:v>998.11469999999997</c:v>
                </c:pt>
                <c:pt idx="15">
                  <c:v>1030.9580000000001</c:v>
                </c:pt>
                <c:pt idx="16">
                  <c:v>1037.5250000000001</c:v>
                </c:pt>
                <c:pt idx="17">
                  <c:v>1086.7149999999999</c:v>
                </c:pt>
                <c:pt idx="18">
                  <c:v>1088.557</c:v>
                </c:pt>
                <c:pt idx="19">
                  <c:v>1111.6220000000001</c:v>
                </c:pt>
                <c:pt idx="20">
                  <c:v>1126</c:v>
                </c:pt>
                <c:pt idx="21">
                  <c:v>1127.231</c:v>
                </c:pt>
                <c:pt idx="22">
                  <c:v>1131.7349999999999</c:v>
                </c:pt>
                <c:pt idx="23">
                  <c:v>1210.338</c:v>
                </c:pt>
                <c:pt idx="24">
                  <c:v>1225.0350000000001</c:v>
                </c:pt>
                <c:pt idx="25">
                  <c:v>1259.759</c:v>
                </c:pt>
                <c:pt idx="26">
                  <c:v>1279.6980000000001</c:v>
                </c:pt>
                <c:pt idx="27">
                  <c:v>1292.7650000000001</c:v>
                </c:pt>
                <c:pt idx="28">
                  <c:v>1296.931</c:v>
                </c:pt>
                <c:pt idx="29">
                  <c:v>1391.84</c:v>
                </c:pt>
                <c:pt idx="30">
                  <c:v>1397.941</c:v>
                </c:pt>
                <c:pt idx="31">
                  <c:v>1465.106</c:v>
                </c:pt>
                <c:pt idx="32">
                  <c:v>1490.2329999999999</c:v>
                </c:pt>
                <c:pt idx="33">
                  <c:v>1536.5360000000001</c:v>
                </c:pt>
                <c:pt idx="34">
                  <c:v>1547.867</c:v>
                </c:pt>
                <c:pt idx="35">
                  <c:v>1558.104</c:v>
                </c:pt>
                <c:pt idx="36">
                  <c:v>1575.873</c:v>
                </c:pt>
                <c:pt idx="37">
                  <c:v>1597.136</c:v>
                </c:pt>
                <c:pt idx="38">
                  <c:v>1597.8810000000001</c:v>
                </c:pt>
                <c:pt idx="39">
                  <c:v>1619.6320000000001</c:v>
                </c:pt>
                <c:pt idx="40">
                  <c:v>1625.2950000000001</c:v>
                </c:pt>
                <c:pt idx="41">
                  <c:v>1663.5709999999999</c:v>
                </c:pt>
                <c:pt idx="42">
                  <c:v>1668.1120000000001</c:v>
                </c:pt>
                <c:pt idx="43">
                  <c:v>1689.7909999999999</c:v>
                </c:pt>
                <c:pt idx="44">
                  <c:v>1692.2380000000001</c:v>
                </c:pt>
                <c:pt idx="45">
                  <c:v>1692.681</c:v>
                </c:pt>
                <c:pt idx="46">
                  <c:v>1743.33</c:v>
                </c:pt>
                <c:pt idx="47">
                  <c:v>1745.3910000000001</c:v>
                </c:pt>
                <c:pt idx="48">
                  <c:v>1814.894</c:v>
                </c:pt>
                <c:pt idx="49">
                  <c:v>1822.183</c:v>
                </c:pt>
                <c:pt idx="50">
                  <c:v>1825.2429999999999</c:v>
                </c:pt>
                <c:pt idx="51">
                  <c:v>1863.27</c:v>
                </c:pt>
                <c:pt idx="52">
                  <c:v>1905.92</c:v>
                </c:pt>
                <c:pt idx="53">
                  <c:v>1962.3869999999999</c:v>
                </c:pt>
                <c:pt idx="54">
                  <c:v>2107.3249999999998</c:v>
                </c:pt>
                <c:pt idx="55">
                  <c:v>2111.6570000000002</c:v>
                </c:pt>
                <c:pt idx="56">
                  <c:v>2139.8620000000001</c:v>
                </c:pt>
                <c:pt idx="57">
                  <c:v>2142.8029999999999</c:v>
                </c:pt>
                <c:pt idx="58">
                  <c:v>2175.1970000000001</c:v>
                </c:pt>
                <c:pt idx="59">
                  <c:v>2185.1790000000001</c:v>
                </c:pt>
                <c:pt idx="60">
                  <c:v>2212.3090000000002</c:v>
                </c:pt>
                <c:pt idx="61">
                  <c:v>2250.7930000000001</c:v>
                </c:pt>
                <c:pt idx="62">
                  <c:v>2297.0659999999998</c:v>
                </c:pt>
                <c:pt idx="63">
                  <c:v>2309.146999999999</c:v>
                </c:pt>
                <c:pt idx="64">
                  <c:v>2315.489</c:v>
                </c:pt>
                <c:pt idx="65">
                  <c:v>2320.933</c:v>
                </c:pt>
                <c:pt idx="66">
                  <c:v>2352.764999999999</c:v>
                </c:pt>
                <c:pt idx="67">
                  <c:v>2361.2260000000001</c:v>
                </c:pt>
                <c:pt idx="68">
                  <c:v>2361.5729999999999</c:v>
                </c:pt>
                <c:pt idx="69">
                  <c:v>2381.684999999999</c:v>
                </c:pt>
                <c:pt idx="70">
                  <c:v>2392.9059999999999</c:v>
                </c:pt>
                <c:pt idx="71">
                  <c:v>2424.4630000000002</c:v>
                </c:pt>
                <c:pt idx="72">
                  <c:v>2435.8870000000002</c:v>
                </c:pt>
                <c:pt idx="73">
                  <c:v>2436.277</c:v>
                </c:pt>
                <c:pt idx="74">
                  <c:v>2440.4299999999998</c:v>
                </c:pt>
                <c:pt idx="75">
                  <c:v>2471.280999999999</c:v>
                </c:pt>
                <c:pt idx="76">
                  <c:v>2485.0329999999999</c:v>
                </c:pt>
                <c:pt idx="77">
                  <c:v>2552.7240000000002</c:v>
                </c:pt>
                <c:pt idx="78">
                  <c:v>2590.6039999999998</c:v>
                </c:pt>
                <c:pt idx="79">
                  <c:v>2592.529</c:v>
                </c:pt>
                <c:pt idx="80">
                  <c:v>2603.748999999998</c:v>
                </c:pt>
                <c:pt idx="81">
                  <c:v>2606.989</c:v>
                </c:pt>
                <c:pt idx="82">
                  <c:v>2625.7280000000001</c:v>
                </c:pt>
                <c:pt idx="83">
                  <c:v>2645.204999999999</c:v>
                </c:pt>
                <c:pt idx="84">
                  <c:v>2653.8960000000002</c:v>
                </c:pt>
                <c:pt idx="85">
                  <c:v>2727.7420000000002</c:v>
                </c:pt>
                <c:pt idx="86">
                  <c:v>2738.54</c:v>
                </c:pt>
                <c:pt idx="87">
                  <c:v>2750.8139999999999</c:v>
                </c:pt>
                <c:pt idx="88">
                  <c:v>2766.0189999999998</c:v>
                </c:pt>
                <c:pt idx="89">
                  <c:v>2777.9720000000002</c:v>
                </c:pt>
                <c:pt idx="90">
                  <c:v>2816.0630000000001</c:v>
                </c:pt>
                <c:pt idx="91">
                  <c:v>2820.634</c:v>
                </c:pt>
                <c:pt idx="92">
                  <c:v>2873.913</c:v>
                </c:pt>
                <c:pt idx="93">
                  <c:v>2894.9639999999999</c:v>
                </c:pt>
                <c:pt idx="94">
                  <c:v>2943.047</c:v>
                </c:pt>
                <c:pt idx="95">
                  <c:v>3092.6329999999998</c:v>
                </c:pt>
                <c:pt idx="96">
                  <c:v>3107.8760000000002</c:v>
                </c:pt>
                <c:pt idx="97">
                  <c:v>3160.587</c:v>
                </c:pt>
                <c:pt idx="98">
                  <c:v>3183.489</c:v>
                </c:pt>
                <c:pt idx="99">
                  <c:v>3297.2750000000001</c:v>
                </c:pt>
                <c:pt idx="100">
                  <c:v>3348.666999999999</c:v>
                </c:pt>
                <c:pt idx="101">
                  <c:v>3527.9769999999999</c:v>
                </c:pt>
                <c:pt idx="102">
                  <c:v>3711.784999999998</c:v>
                </c:pt>
                <c:pt idx="103">
                  <c:v>3742.3939999999998</c:v>
                </c:pt>
                <c:pt idx="104">
                  <c:v>3814.7539999999999</c:v>
                </c:pt>
                <c:pt idx="105">
                  <c:v>3914.0039999999999</c:v>
                </c:pt>
                <c:pt idx="106">
                  <c:v>3980.768</c:v>
                </c:pt>
                <c:pt idx="107">
                  <c:v>3997.9180000000001</c:v>
                </c:pt>
                <c:pt idx="108">
                  <c:v>4062.6</c:v>
                </c:pt>
                <c:pt idx="109">
                  <c:v>4153.2170000000006</c:v>
                </c:pt>
                <c:pt idx="110">
                  <c:v>4168.808</c:v>
                </c:pt>
                <c:pt idx="111">
                  <c:v>4210.201</c:v>
                </c:pt>
                <c:pt idx="112">
                  <c:v>4214.2420000000002</c:v>
                </c:pt>
                <c:pt idx="113">
                  <c:v>4257.7030000000004</c:v>
                </c:pt>
                <c:pt idx="114">
                  <c:v>4294.5219999999999</c:v>
                </c:pt>
                <c:pt idx="115">
                  <c:v>4479.4739999999974</c:v>
                </c:pt>
                <c:pt idx="116">
                  <c:v>4625.4979999999996</c:v>
                </c:pt>
                <c:pt idx="117">
                  <c:v>4873.0170000000007</c:v>
                </c:pt>
                <c:pt idx="118">
                  <c:v>5014.13</c:v>
                </c:pt>
                <c:pt idx="119">
                  <c:v>5077.0410000000002</c:v>
                </c:pt>
                <c:pt idx="120">
                  <c:v>5093.9399999999996</c:v>
                </c:pt>
                <c:pt idx="121">
                  <c:v>5148.3220000000001</c:v>
                </c:pt>
                <c:pt idx="122">
                  <c:v>5151.8220000000001</c:v>
                </c:pt>
                <c:pt idx="123">
                  <c:v>5276.576</c:v>
                </c:pt>
                <c:pt idx="124">
                  <c:v>5670.2910000000002</c:v>
                </c:pt>
                <c:pt idx="125">
                  <c:v>5681.6289999999999</c:v>
                </c:pt>
                <c:pt idx="126">
                  <c:v>5877.4660000000003</c:v>
                </c:pt>
                <c:pt idx="127">
                  <c:v>5930.8710000000001</c:v>
                </c:pt>
                <c:pt idx="128">
                  <c:v>5969.808</c:v>
                </c:pt>
                <c:pt idx="129">
                  <c:v>6010.89</c:v>
                </c:pt>
                <c:pt idx="130">
                  <c:v>6042.6279999999997</c:v>
                </c:pt>
                <c:pt idx="131">
                  <c:v>6270.8209999999999</c:v>
                </c:pt>
                <c:pt idx="132">
                  <c:v>6371.7190000000001</c:v>
                </c:pt>
                <c:pt idx="133">
                  <c:v>6482.1779999999999</c:v>
                </c:pt>
                <c:pt idx="134">
                  <c:v>6628.5780000000004</c:v>
                </c:pt>
                <c:pt idx="135">
                  <c:v>6897.2790000000005</c:v>
                </c:pt>
                <c:pt idx="136">
                  <c:v>7106.8770000000004</c:v>
                </c:pt>
                <c:pt idx="137">
                  <c:v>7239.7039999999997</c:v>
                </c:pt>
                <c:pt idx="138">
                  <c:v>7510.8470000000007</c:v>
                </c:pt>
                <c:pt idx="139">
                  <c:v>7674.8590000000004</c:v>
                </c:pt>
                <c:pt idx="140">
                  <c:v>7722.7570000000014</c:v>
                </c:pt>
                <c:pt idx="141">
                  <c:v>8276.2150000000001</c:v>
                </c:pt>
                <c:pt idx="142">
                  <c:v>8821.68</c:v>
                </c:pt>
                <c:pt idx="143">
                  <c:v>9039.8059999999914</c:v>
                </c:pt>
                <c:pt idx="144">
                  <c:v>9101.4449999999943</c:v>
                </c:pt>
                <c:pt idx="145">
                  <c:v>9557.6329999999944</c:v>
                </c:pt>
                <c:pt idx="146">
                  <c:v>9570.19</c:v>
                </c:pt>
                <c:pt idx="147">
                  <c:v>10742.27</c:v>
                </c:pt>
                <c:pt idx="148">
                  <c:v>11725.15</c:v>
                </c:pt>
                <c:pt idx="149">
                  <c:v>12105.87</c:v>
                </c:pt>
                <c:pt idx="150">
                  <c:v>13163.3</c:v>
                </c:pt>
                <c:pt idx="151">
                  <c:v>13557.5</c:v>
                </c:pt>
                <c:pt idx="152">
                  <c:v>16399.599999999991</c:v>
                </c:pt>
                <c:pt idx="153">
                  <c:v>18093.89</c:v>
                </c:pt>
                <c:pt idx="154">
                  <c:v>22220.32</c:v>
                </c:pt>
              </c:numCache>
            </c:numRef>
          </c:xVal>
          <c:yVal>
            <c:numRef>
              <c:f>Sheet2!$X$2:$X$156</c:f>
              <c:numCache>
                <c:formatCode>General</c:formatCode>
                <c:ptCount val="155"/>
                <c:pt idx="0">
                  <c:v>30</c:v>
                </c:pt>
                <c:pt idx="1">
                  <c:v>8</c:v>
                </c:pt>
                <c:pt idx="2">
                  <c:v>12</c:v>
                </c:pt>
                <c:pt idx="3">
                  <c:v>47</c:v>
                </c:pt>
                <c:pt idx="4">
                  <c:v>9</c:v>
                </c:pt>
                <c:pt idx="5">
                  <c:v>4</c:v>
                </c:pt>
                <c:pt idx="6">
                  <c:v>1</c:v>
                </c:pt>
                <c:pt idx="7">
                  <c:v>21</c:v>
                </c:pt>
                <c:pt idx="8">
                  <c:v>8</c:v>
                </c:pt>
                <c:pt idx="9">
                  <c:v>15</c:v>
                </c:pt>
                <c:pt idx="10">
                  <c:v>27</c:v>
                </c:pt>
                <c:pt idx="11">
                  <c:v>10</c:v>
                </c:pt>
                <c:pt idx="12">
                  <c:v>2</c:v>
                </c:pt>
                <c:pt idx="13">
                  <c:v>10</c:v>
                </c:pt>
                <c:pt idx="14">
                  <c:v>18</c:v>
                </c:pt>
                <c:pt idx="15">
                  <c:v>31</c:v>
                </c:pt>
                <c:pt idx="16">
                  <c:v>6</c:v>
                </c:pt>
                <c:pt idx="17">
                  <c:v>1</c:v>
                </c:pt>
                <c:pt idx="18">
                  <c:v>12</c:v>
                </c:pt>
                <c:pt idx="19">
                  <c:v>7</c:v>
                </c:pt>
                <c:pt idx="20">
                  <c:v>12</c:v>
                </c:pt>
                <c:pt idx="21">
                  <c:v>1</c:v>
                </c:pt>
                <c:pt idx="22">
                  <c:v>2</c:v>
                </c:pt>
                <c:pt idx="23">
                  <c:v>10</c:v>
                </c:pt>
                <c:pt idx="24">
                  <c:v>22</c:v>
                </c:pt>
                <c:pt idx="25">
                  <c:v>22</c:v>
                </c:pt>
                <c:pt idx="26">
                  <c:v>9</c:v>
                </c:pt>
                <c:pt idx="27">
                  <c:v>63</c:v>
                </c:pt>
                <c:pt idx="28">
                  <c:v>9</c:v>
                </c:pt>
                <c:pt idx="29">
                  <c:v>24</c:v>
                </c:pt>
                <c:pt idx="30">
                  <c:v>8</c:v>
                </c:pt>
                <c:pt idx="31">
                  <c:v>9</c:v>
                </c:pt>
                <c:pt idx="32">
                  <c:v>13</c:v>
                </c:pt>
                <c:pt idx="33">
                  <c:v>34</c:v>
                </c:pt>
                <c:pt idx="34">
                  <c:v>13</c:v>
                </c:pt>
                <c:pt idx="35">
                  <c:v>11</c:v>
                </c:pt>
                <c:pt idx="36">
                  <c:v>15</c:v>
                </c:pt>
                <c:pt idx="37">
                  <c:v>39</c:v>
                </c:pt>
                <c:pt idx="38">
                  <c:v>36</c:v>
                </c:pt>
                <c:pt idx="39">
                  <c:v>92</c:v>
                </c:pt>
                <c:pt idx="40">
                  <c:v>74</c:v>
                </c:pt>
                <c:pt idx="41">
                  <c:v>8</c:v>
                </c:pt>
                <c:pt idx="42">
                  <c:v>31</c:v>
                </c:pt>
                <c:pt idx="43">
                  <c:v>8</c:v>
                </c:pt>
                <c:pt idx="44">
                  <c:v>3</c:v>
                </c:pt>
                <c:pt idx="45">
                  <c:v>28</c:v>
                </c:pt>
                <c:pt idx="46">
                  <c:v>33</c:v>
                </c:pt>
                <c:pt idx="47">
                  <c:v>14</c:v>
                </c:pt>
                <c:pt idx="48">
                  <c:v>114</c:v>
                </c:pt>
                <c:pt idx="49">
                  <c:v>19</c:v>
                </c:pt>
                <c:pt idx="50">
                  <c:v>22</c:v>
                </c:pt>
                <c:pt idx="51">
                  <c:v>30</c:v>
                </c:pt>
                <c:pt idx="52">
                  <c:v>59</c:v>
                </c:pt>
                <c:pt idx="53">
                  <c:v>66</c:v>
                </c:pt>
                <c:pt idx="54">
                  <c:v>35</c:v>
                </c:pt>
                <c:pt idx="55">
                  <c:v>41</c:v>
                </c:pt>
                <c:pt idx="56">
                  <c:v>63</c:v>
                </c:pt>
                <c:pt idx="57">
                  <c:v>35</c:v>
                </c:pt>
                <c:pt idx="58">
                  <c:v>19</c:v>
                </c:pt>
                <c:pt idx="59">
                  <c:v>27</c:v>
                </c:pt>
                <c:pt idx="60">
                  <c:v>44</c:v>
                </c:pt>
                <c:pt idx="61">
                  <c:v>19</c:v>
                </c:pt>
                <c:pt idx="62">
                  <c:v>70</c:v>
                </c:pt>
                <c:pt idx="63">
                  <c:v>11</c:v>
                </c:pt>
                <c:pt idx="64">
                  <c:v>35</c:v>
                </c:pt>
                <c:pt idx="65">
                  <c:v>62</c:v>
                </c:pt>
                <c:pt idx="66">
                  <c:v>18</c:v>
                </c:pt>
                <c:pt idx="67">
                  <c:v>4</c:v>
                </c:pt>
                <c:pt idx="68">
                  <c:v>6</c:v>
                </c:pt>
                <c:pt idx="69">
                  <c:v>140</c:v>
                </c:pt>
                <c:pt idx="70">
                  <c:v>83</c:v>
                </c:pt>
                <c:pt idx="71">
                  <c:v>32</c:v>
                </c:pt>
                <c:pt idx="72">
                  <c:v>100</c:v>
                </c:pt>
                <c:pt idx="73">
                  <c:v>132</c:v>
                </c:pt>
                <c:pt idx="74">
                  <c:v>9</c:v>
                </c:pt>
                <c:pt idx="75">
                  <c:v>32</c:v>
                </c:pt>
                <c:pt idx="76">
                  <c:v>36</c:v>
                </c:pt>
                <c:pt idx="77">
                  <c:v>28</c:v>
                </c:pt>
                <c:pt idx="78">
                  <c:v>143</c:v>
                </c:pt>
                <c:pt idx="79">
                  <c:v>134</c:v>
                </c:pt>
                <c:pt idx="80">
                  <c:v>83</c:v>
                </c:pt>
                <c:pt idx="81">
                  <c:v>77</c:v>
                </c:pt>
                <c:pt idx="82">
                  <c:v>112</c:v>
                </c:pt>
                <c:pt idx="83">
                  <c:v>123</c:v>
                </c:pt>
                <c:pt idx="84">
                  <c:v>40</c:v>
                </c:pt>
                <c:pt idx="85">
                  <c:v>53</c:v>
                </c:pt>
                <c:pt idx="86">
                  <c:v>38</c:v>
                </c:pt>
                <c:pt idx="87">
                  <c:v>102</c:v>
                </c:pt>
                <c:pt idx="88">
                  <c:v>38</c:v>
                </c:pt>
                <c:pt idx="89">
                  <c:v>47</c:v>
                </c:pt>
                <c:pt idx="90">
                  <c:v>318</c:v>
                </c:pt>
                <c:pt idx="91">
                  <c:v>99</c:v>
                </c:pt>
                <c:pt idx="92">
                  <c:v>82</c:v>
                </c:pt>
                <c:pt idx="93">
                  <c:v>171</c:v>
                </c:pt>
                <c:pt idx="94">
                  <c:v>61</c:v>
                </c:pt>
                <c:pt idx="95">
                  <c:v>73</c:v>
                </c:pt>
                <c:pt idx="96">
                  <c:v>59</c:v>
                </c:pt>
                <c:pt idx="97">
                  <c:v>38</c:v>
                </c:pt>
                <c:pt idx="98">
                  <c:v>129</c:v>
                </c:pt>
                <c:pt idx="99">
                  <c:v>32</c:v>
                </c:pt>
                <c:pt idx="100">
                  <c:v>89</c:v>
                </c:pt>
                <c:pt idx="101">
                  <c:v>92</c:v>
                </c:pt>
                <c:pt idx="102">
                  <c:v>33</c:v>
                </c:pt>
                <c:pt idx="103">
                  <c:v>88</c:v>
                </c:pt>
                <c:pt idx="104">
                  <c:v>88</c:v>
                </c:pt>
                <c:pt idx="105">
                  <c:v>70</c:v>
                </c:pt>
                <c:pt idx="106">
                  <c:v>98</c:v>
                </c:pt>
                <c:pt idx="107">
                  <c:v>153</c:v>
                </c:pt>
                <c:pt idx="108">
                  <c:v>101</c:v>
                </c:pt>
                <c:pt idx="109">
                  <c:v>73</c:v>
                </c:pt>
                <c:pt idx="110">
                  <c:v>89</c:v>
                </c:pt>
                <c:pt idx="111">
                  <c:v>107</c:v>
                </c:pt>
                <c:pt idx="112">
                  <c:v>70</c:v>
                </c:pt>
                <c:pt idx="113">
                  <c:v>351</c:v>
                </c:pt>
                <c:pt idx="114">
                  <c:v>23</c:v>
                </c:pt>
                <c:pt idx="115">
                  <c:v>115</c:v>
                </c:pt>
                <c:pt idx="116">
                  <c:v>152</c:v>
                </c:pt>
                <c:pt idx="117">
                  <c:v>262</c:v>
                </c:pt>
                <c:pt idx="118">
                  <c:v>105</c:v>
                </c:pt>
                <c:pt idx="119">
                  <c:v>115</c:v>
                </c:pt>
                <c:pt idx="120">
                  <c:v>104</c:v>
                </c:pt>
                <c:pt idx="121">
                  <c:v>220</c:v>
                </c:pt>
                <c:pt idx="122">
                  <c:v>138</c:v>
                </c:pt>
                <c:pt idx="123">
                  <c:v>149</c:v>
                </c:pt>
                <c:pt idx="124">
                  <c:v>354</c:v>
                </c:pt>
                <c:pt idx="125">
                  <c:v>596</c:v>
                </c:pt>
                <c:pt idx="126">
                  <c:v>79</c:v>
                </c:pt>
                <c:pt idx="127">
                  <c:v>242</c:v>
                </c:pt>
                <c:pt idx="128">
                  <c:v>33</c:v>
                </c:pt>
                <c:pt idx="129">
                  <c:v>47</c:v>
                </c:pt>
                <c:pt idx="130">
                  <c:v>41</c:v>
                </c:pt>
                <c:pt idx="131">
                  <c:v>228</c:v>
                </c:pt>
                <c:pt idx="132">
                  <c:v>390</c:v>
                </c:pt>
                <c:pt idx="133">
                  <c:v>252</c:v>
                </c:pt>
                <c:pt idx="134">
                  <c:v>158</c:v>
                </c:pt>
                <c:pt idx="135">
                  <c:v>412</c:v>
                </c:pt>
                <c:pt idx="136">
                  <c:v>62</c:v>
                </c:pt>
                <c:pt idx="137">
                  <c:v>334</c:v>
                </c:pt>
                <c:pt idx="138">
                  <c:v>662</c:v>
                </c:pt>
                <c:pt idx="139">
                  <c:v>161</c:v>
                </c:pt>
                <c:pt idx="140">
                  <c:v>201</c:v>
                </c:pt>
                <c:pt idx="141">
                  <c:v>305</c:v>
                </c:pt>
                <c:pt idx="142">
                  <c:v>385</c:v>
                </c:pt>
                <c:pt idx="143">
                  <c:v>1453</c:v>
                </c:pt>
                <c:pt idx="144">
                  <c:v>568</c:v>
                </c:pt>
                <c:pt idx="145">
                  <c:v>700</c:v>
                </c:pt>
                <c:pt idx="146">
                  <c:v>387</c:v>
                </c:pt>
                <c:pt idx="147">
                  <c:v>94</c:v>
                </c:pt>
                <c:pt idx="148">
                  <c:v>1040</c:v>
                </c:pt>
                <c:pt idx="149">
                  <c:v>285</c:v>
                </c:pt>
                <c:pt idx="150">
                  <c:v>332</c:v>
                </c:pt>
                <c:pt idx="151">
                  <c:v>1325</c:v>
                </c:pt>
                <c:pt idx="152">
                  <c:v>906</c:v>
                </c:pt>
                <c:pt idx="153">
                  <c:v>1242</c:v>
                </c:pt>
                <c:pt idx="154">
                  <c:v>578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BC41-44CF-A17B-420CEB86AADF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77325312"/>
        <c:axId val="178495984"/>
      </c:scatterChart>
      <c:valAx>
        <c:axId val="177325312"/>
        <c:scaling>
          <c:orientation val="minMax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0" vert="horz"/>
              <a:lstStyle/>
              <a:p>
                <a:pPr>
                  <a:defRPr/>
                </a:pPr>
                <a:r>
                  <a:rPr lang="en-US"/>
                  <a:t>AQUA Score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vert="horz"/>
          <a:lstStyle/>
          <a:p>
            <a:pPr>
              <a:defRPr/>
            </a:pPr>
            <a:endParaRPr lang="en-US"/>
          </a:p>
        </c:txPr>
        <c:crossAx val="178495984"/>
        <c:crosses val="autoZero"/>
        <c:crossBetween val="midCat"/>
      </c:valAx>
      <c:valAx>
        <c:axId val="178495984"/>
        <c:scaling>
          <c:orientation val="minMax"/>
          <c:min val="0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/>
                  <a:t>Vectra Cell Count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vert="horz"/>
          <a:lstStyle/>
          <a:p>
            <a:pPr>
              <a:defRPr/>
            </a:pPr>
            <a:endParaRPr lang="en-US"/>
          </a:p>
        </c:txPr>
        <c:crossAx val="177325312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>
          <a:solidFill>
            <a:schemeClr val="tx1"/>
          </a:solidFill>
          <a:latin typeface="Times New Roman"/>
          <a:cs typeface="Times New Roman"/>
        </a:defRPr>
      </a:pPr>
      <a:endParaRPr lang="en-US"/>
    </a:p>
  </c:txPr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vert="horz"/>
          <a:lstStyle/>
          <a:p>
            <a:pPr>
              <a:defRPr/>
            </a:pPr>
            <a:r>
              <a:rPr lang="en-US"/>
              <a:t>CD20: AQUA vs Vectra </a:t>
            </a:r>
          </a:p>
        </c:rich>
      </c:tx>
      <c:overlay val="0"/>
      <c:spPr>
        <a:noFill/>
        <a:ln>
          <a:noFill/>
        </a:ln>
        <a:effectLst/>
      </c:spPr>
    </c:title>
    <c:autoTitleDeleted val="0"/>
    <c:plotArea>
      <c:layout/>
      <c:scatterChart>
        <c:scatterStyle val="lineMarker"/>
        <c:varyColors val="0"/>
        <c:ser>
          <c:idx val="0"/>
          <c:order val="0"/>
          <c:spPr>
            <a:ln w="1905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tx1"/>
              </a:solidFill>
              <a:ln w="9525">
                <a:solidFill>
                  <a:schemeClr val="tx1"/>
                </a:solidFill>
              </a:ln>
              <a:effectLst/>
            </c:spPr>
          </c:marker>
          <c:trendline>
            <c:spPr>
              <a:ln w="19050" cap="rnd">
                <a:solidFill>
                  <a:schemeClr val="accent1"/>
                </a:solidFill>
                <a:prstDash val="sysDot"/>
              </a:ln>
              <a:effectLst/>
            </c:spPr>
            <c:trendlineType val="linear"/>
            <c:dispRSqr val="1"/>
            <c:dispEq val="0"/>
            <c:trendlineLbl>
              <c:layout>
                <c:manualLayout>
                  <c:x val="0.18755800918803414"/>
                  <c:y val="-2.8691183597553255E-2"/>
                </c:manualLayout>
              </c:layout>
              <c:numFmt formatCode="General" sourceLinked="0"/>
              <c:spPr>
                <a:noFill/>
                <a:ln>
                  <a:noFill/>
                </a:ln>
                <a:effectLst/>
              </c:spPr>
              <c:txPr>
                <a:bodyPr rot="0" vert="horz"/>
                <a:lstStyle/>
                <a:p>
                  <a:pPr>
                    <a:defRPr/>
                  </a:pPr>
                  <a:endParaRPr lang="en-US"/>
                </a:p>
              </c:txPr>
            </c:trendlineLbl>
          </c:trendline>
          <c:xVal>
            <c:numRef>
              <c:f>Sheet2!$AA$2:$AA$70</c:f>
              <c:numCache>
                <c:formatCode>General</c:formatCode>
                <c:ptCount val="69"/>
                <c:pt idx="0">
                  <c:v>36.379989999999999</c:v>
                </c:pt>
                <c:pt idx="1">
                  <c:v>49.402810000000002</c:v>
                </c:pt>
                <c:pt idx="2">
                  <c:v>50.108809999999998</c:v>
                </c:pt>
                <c:pt idx="3">
                  <c:v>54.175530000000002</c:v>
                </c:pt>
                <c:pt idx="4">
                  <c:v>57.03942</c:v>
                </c:pt>
                <c:pt idx="5">
                  <c:v>57.717210000000001</c:v>
                </c:pt>
                <c:pt idx="6">
                  <c:v>59.689160000000001</c:v>
                </c:pt>
                <c:pt idx="7">
                  <c:v>60.195630000000001</c:v>
                </c:pt>
                <c:pt idx="8">
                  <c:v>61.761299999999999</c:v>
                </c:pt>
                <c:pt idx="9">
                  <c:v>64.723729999999975</c:v>
                </c:pt>
                <c:pt idx="10">
                  <c:v>66.18389999999998</c:v>
                </c:pt>
                <c:pt idx="11">
                  <c:v>74.834500000000006</c:v>
                </c:pt>
                <c:pt idx="12">
                  <c:v>77.018289999999993</c:v>
                </c:pt>
                <c:pt idx="13">
                  <c:v>79.106479999999976</c:v>
                </c:pt>
                <c:pt idx="14">
                  <c:v>82.253709999999998</c:v>
                </c:pt>
                <c:pt idx="15">
                  <c:v>83.643749999999983</c:v>
                </c:pt>
                <c:pt idx="16">
                  <c:v>84.909649999999999</c:v>
                </c:pt>
                <c:pt idx="17">
                  <c:v>84.921599999999998</c:v>
                </c:pt>
                <c:pt idx="18">
                  <c:v>89.174520000000001</c:v>
                </c:pt>
                <c:pt idx="19">
                  <c:v>91.619799999999998</c:v>
                </c:pt>
                <c:pt idx="20">
                  <c:v>91.67910999999998</c:v>
                </c:pt>
                <c:pt idx="21">
                  <c:v>92.986000000000004</c:v>
                </c:pt>
                <c:pt idx="22">
                  <c:v>93.875669999999985</c:v>
                </c:pt>
                <c:pt idx="23">
                  <c:v>96.191469999999995</c:v>
                </c:pt>
                <c:pt idx="24">
                  <c:v>96.232369999999975</c:v>
                </c:pt>
                <c:pt idx="25">
                  <c:v>97.792400000000001</c:v>
                </c:pt>
                <c:pt idx="26">
                  <c:v>107.09820000000001</c:v>
                </c:pt>
                <c:pt idx="27">
                  <c:v>111.7385</c:v>
                </c:pt>
                <c:pt idx="28">
                  <c:v>113.1461</c:v>
                </c:pt>
                <c:pt idx="29">
                  <c:v>114.83369999999999</c:v>
                </c:pt>
                <c:pt idx="30">
                  <c:v>117.27849999999999</c:v>
                </c:pt>
                <c:pt idx="31">
                  <c:v>123.605</c:v>
                </c:pt>
                <c:pt idx="32">
                  <c:v>124.4058</c:v>
                </c:pt>
                <c:pt idx="33">
                  <c:v>125.0517</c:v>
                </c:pt>
                <c:pt idx="34">
                  <c:v>132.70179999999999</c:v>
                </c:pt>
                <c:pt idx="35">
                  <c:v>134.255</c:v>
                </c:pt>
                <c:pt idx="36">
                  <c:v>134.66220000000001</c:v>
                </c:pt>
                <c:pt idx="37">
                  <c:v>134.9127</c:v>
                </c:pt>
                <c:pt idx="38">
                  <c:v>140.2287</c:v>
                </c:pt>
                <c:pt idx="39">
                  <c:v>143.47559999999999</c:v>
                </c:pt>
                <c:pt idx="40">
                  <c:v>148.11799999999999</c:v>
                </c:pt>
                <c:pt idx="41">
                  <c:v>149.66040000000001</c:v>
                </c:pt>
                <c:pt idx="42">
                  <c:v>150.3424</c:v>
                </c:pt>
                <c:pt idx="43">
                  <c:v>150.90369999999999</c:v>
                </c:pt>
                <c:pt idx="44">
                  <c:v>162.96449999999999</c:v>
                </c:pt>
                <c:pt idx="45">
                  <c:v>164.02879999999999</c:v>
                </c:pt>
                <c:pt idx="46">
                  <c:v>166.7276</c:v>
                </c:pt>
                <c:pt idx="47">
                  <c:v>173.07730000000001</c:v>
                </c:pt>
                <c:pt idx="48">
                  <c:v>187.70230000000001</c:v>
                </c:pt>
                <c:pt idx="49">
                  <c:v>194.51750000000001</c:v>
                </c:pt>
                <c:pt idx="50">
                  <c:v>196.45160000000001</c:v>
                </c:pt>
                <c:pt idx="51">
                  <c:v>205.96469999999999</c:v>
                </c:pt>
                <c:pt idx="52">
                  <c:v>225.04580000000001</c:v>
                </c:pt>
                <c:pt idx="53">
                  <c:v>236.9888</c:v>
                </c:pt>
                <c:pt idx="54">
                  <c:v>242.12780000000001</c:v>
                </c:pt>
                <c:pt idx="55">
                  <c:v>256.26960000000008</c:v>
                </c:pt>
                <c:pt idx="56">
                  <c:v>271.71030000000002</c:v>
                </c:pt>
                <c:pt idx="57">
                  <c:v>275.85419999999999</c:v>
                </c:pt>
                <c:pt idx="58">
                  <c:v>302.9918999999997</c:v>
                </c:pt>
                <c:pt idx="59">
                  <c:v>390.7946</c:v>
                </c:pt>
                <c:pt idx="60">
                  <c:v>465.2534</c:v>
                </c:pt>
                <c:pt idx="61">
                  <c:v>507.60899999999992</c:v>
                </c:pt>
                <c:pt idx="62">
                  <c:v>531.99779999999998</c:v>
                </c:pt>
                <c:pt idx="63">
                  <c:v>547.69010000000003</c:v>
                </c:pt>
                <c:pt idx="64">
                  <c:v>670.11739999999998</c:v>
                </c:pt>
                <c:pt idx="65">
                  <c:v>823.32809999999961</c:v>
                </c:pt>
                <c:pt idx="66">
                  <c:v>1384.914</c:v>
                </c:pt>
                <c:pt idx="67">
                  <c:v>1710.925</c:v>
                </c:pt>
                <c:pt idx="68">
                  <c:v>3825.027</c:v>
                </c:pt>
              </c:numCache>
            </c:numRef>
          </c:xVal>
          <c:yVal>
            <c:numRef>
              <c:f>Sheet2!$AB$2:$AB$70</c:f>
              <c:numCache>
                <c:formatCode>General</c:formatCode>
                <c:ptCount val="69"/>
                <c:pt idx="0">
                  <c:v>1</c:v>
                </c:pt>
                <c:pt idx="1">
                  <c:v>9</c:v>
                </c:pt>
                <c:pt idx="2">
                  <c:v>1</c:v>
                </c:pt>
                <c:pt idx="3">
                  <c:v>1</c:v>
                </c:pt>
                <c:pt idx="4">
                  <c:v>6</c:v>
                </c:pt>
                <c:pt idx="5">
                  <c:v>3</c:v>
                </c:pt>
                <c:pt idx="6">
                  <c:v>3</c:v>
                </c:pt>
                <c:pt idx="7">
                  <c:v>2</c:v>
                </c:pt>
                <c:pt idx="8">
                  <c:v>5</c:v>
                </c:pt>
                <c:pt idx="9">
                  <c:v>3</c:v>
                </c:pt>
                <c:pt idx="10">
                  <c:v>1</c:v>
                </c:pt>
                <c:pt idx="11">
                  <c:v>1</c:v>
                </c:pt>
                <c:pt idx="12">
                  <c:v>2</c:v>
                </c:pt>
                <c:pt idx="13">
                  <c:v>15</c:v>
                </c:pt>
                <c:pt idx="14">
                  <c:v>12</c:v>
                </c:pt>
                <c:pt idx="15">
                  <c:v>5</c:v>
                </c:pt>
                <c:pt idx="16">
                  <c:v>2</c:v>
                </c:pt>
                <c:pt idx="17">
                  <c:v>2</c:v>
                </c:pt>
                <c:pt idx="18">
                  <c:v>1</c:v>
                </c:pt>
                <c:pt idx="19">
                  <c:v>3</c:v>
                </c:pt>
                <c:pt idx="20">
                  <c:v>6</c:v>
                </c:pt>
                <c:pt idx="21">
                  <c:v>1</c:v>
                </c:pt>
                <c:pt idx="22">
                  <c:v>16</c:v>
                </c:pt>
                <c:pt idx="23">
                  <c:v>1</c:v>
                </c:pt>
                <c:pt idx="24">
                  <c:v>3</c:v>
                </c:pt>
                <c:pt idx="25">
                  <c:v>1</c:v>
                </c:pt>
                <c:pt idx="26">
                  <c:v>3</c:v>
                </c:pt>
                <c:pt idx="27">
                  <c:v>6</c:v>
                </c:pt>
                <c:pt idx="28">
                  <c:v>3</c:v>
                </c:pt>
                <c:pt idx="29">
                  <c:v>26</c:v>
                </c:pt>
                <c:pt idx="30">
                  <c:v>35</c:v>
                </c:pt>
                <c:pt idx="31">
                  <c:v>14</c:v>
                </c:pt>
                <c:pt idx="32">
                  <c:v>11</c:v>
                </c:pt>
                <c:pt idx="33">
                  <c:v>11</c:v>
                </c:pt>
                <c:pt idx="34">
                  <c:v>7</c:v>
                </c:pt>
                <c:pt idx="35">
                  <c:v>1</c:v>
                </c:pt>
                <c:pt idx="36">
                  <c:v>24</c:v>
                </c:pt>
                <c:pt idx="37">
                  <c:v>4</c:v>
                </c:pt>
                <c:pt idx="38">
                  <c:v>34</c:v>
                </c:pt>
                <c:pt idx="39">
                  <c:v>18</c:v>
                </c:pt>
                <c:pt idx="40">
                  <c:v>25</c:v>
                </c:pt>
                <c:pt idx="41">
                  <c:v>7</c:v>
                </c:pt>
                <c:pt idx="42">
                  <c:v>70</c:v>
                </c:pt>
                <c:pt idx="43">
                  <c:v>16</c:v>
                </c:pt>
                <c:pt idx="44">
                  <c:v>2</c:v>
                </c:pt>
                <c:pt idx="45">
                  <c:v>50</c:v>
                </c:pt>
                <c:pt idx="46">
                  <c:v>89</c:v>
                </c:pt>
                <c:pt idx="47">
                  <c:v>58</c:v>
                </c:pt>
                <c:pt idx="48">
                  <c:v>24</c:v>
                </c:pt>
                <c:pt idx="49">
                  <c:v>1</c:v>
                </c:pt>
                <c:pt idx="50">
                  <c:v>1</c:v>
                </c:pt>
                <c:pt idx="51">
                  <c:v>10</c:v>
                </c:pt>
                <c:pt idx="52">
                  <c:v>125</c:v>
                </c:pt>
                <c:pt idx="53">
                  <c:v>70</c:v>
                </c:pt>
                <c:pt idx="54">
                  <c:v>1</c:v>
                </c:pt>
                <c:pt idx="55">
                  <c:v>108</c:v>
                </c:pt>
                <c:pt idx="56">
                  <c:v>147</c:v>
                </c:pt>
                <c:pt idx="57">
                  <c:v>1</c:v>
                </c:pt>
                <c:pt idx="58">
                  <c:v>166</c:v>
                </c:pt>
                <c:pt idx="59">
                  <c:v>445</c:v>
                </c:pt>
                <c:pt idx="60">
                  <c:v>107</c:v>
                </c:pt>
                <c:pt idx="61">
                  <c:v>448</c:v>
                </c:pt>
                <c:pt idx="62">
                  <c:v>308</c:v>
                </c:pt>
                <c:pt idx="63">
                  <c:v>320</c:v>
                </c:pt>
                <c:pt idx="64">
                  <c:v>409</c:v>
                </c:pt>
                <c:pt idx="65">
                  <c:v>718</c:v>
                </c:pt>
                <c:pt idx="66">
                  <c:v>2881</c:v>
                </c:pt>
                <c:pt idx="67">
                  <c:v>1308</c:v>
                </c:pt>
                <c:pt idx="68">
                  <c:v>2695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E78D-4AA4-9D44-C96AA822AAE2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78448392"/>
        <c:axId val="176792504"/>
      </c:scatterChart>
      <c:valAx>
        <c:axId val="178448392"/>
        <c:scaling>
          <c:orientation val="minMax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0" vert="horz"/>
              <a:lstStyle/>
              <a:p>
                <a:pPr>
                  <a:defRPr/>
                </a:pPr>
                <a:r>
                  <a:rPr lang="en-US"/>
                  <a:t>AQUA Score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vert="horz"/>
          <a:lstStyle/>
          <a:p>
            <a:pPr>
              <a:defRPr/>
            </a:pPr>
            <a:endParaRPr lang="en-US"/>
          </a:p>
        </c:txPr>
        <c:crossAx val="176792504"/>
        <c:crosses val="autoZero"/>
        <c:crossBetween val="midCat"/>
      </c:valAx>
      <c:valAx>
        <c:axId val="176792504"/>
        <c:scaling>
          <c:orientation val="minMax"/>
          <c:min val="0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/>
                  <a:t>Vectra Cell Count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vert="horz"/>
          <a:lstStyle/>
          <a:p>
            <a:pPr>
              <a:defRPr/>
            </a:pPr>
            <a:endParaRPr lang="en-US"/>
          </a:p>
        </c:txPr>
        <c:crossAx val="178448392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>
          <a:solidFill>
            <a:schemeClr val="tx1"/>
          </a:solidFill>
          <a:latin typeface="Times New Roman"/>
          <a:cs typeface="Times New Roman"/>
        </a:defRPr>
      </a:pPr>
      <a:endParaRPr lang="en-US"/>
    </a:p>
  </c:txPr>
  <c:externalData r:id="rId1">
    <c:autoUpdate val="0"/>
  </c:externalData>
</c:chartSpac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9D9F18DC-5C89-45DF-A238-DAF846D991AB}" type="datetimeFigureOut">
              <a:rPr lang="en-US" smtClean="0"/>
              <a:t>6/20/2016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649BC8C6-0712-4A28-9A0D-66D9A3BCFEC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5119810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Supplementar</a:t>
            </a:r>
            <a:r>
              <a:rPr lang="en-US" baseline="0" dirty="0"/>
              <a:t>y Figure 1</a:t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649BC8C6-0712-4A28-9A0D-66D9A3BCFEC3}" type="slidenum">
              <a:rPr lang="en-US" smtClean="0"/>
              <a:t>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93847452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Should this be added</a:t>
            </a:r>
            <a:r>
              <a:rPr lang="en-US" baseline="0" dirty="0"/>
              <a:t> as a sup figure?</a:t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649BC8C6-0712-4A28-9A0D-66D9A3BCFEC3}" type="slidenum">
              <a:rPr lang="en-US" smtClean="0"/>
              <a:t>4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86148892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047232-3C14-422B-B842-CB59AF35C2AD}" type="datetimeFigureOut">
              <a:rPr lang="en-US" smtClean="0"/>
              <a:pPr/>
              <a:t>6/20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D55BC0-53C9-48DE-A7A7-496C42709A0A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047232-3C14-422B-B842-CB59AF35C2AD}" type="datetimeFigureOut">
              <a:rPr lang="en-US" smtClean="0"/>
              <a:pPr/>
              <a:t>6/20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D55BC0-53C9-48DE-A7A7-496C42709A0A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047232-3C14-422B-B842-CB59AF35C2AD}" type="datetimeFigureOut">
              <a:rPr lang="en-US" smtClean="0"/>
              <a:pPr/>
              <a:t>6/20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D55BC0-53C9-48DE-A7A7-496C42709A0A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047232-3C14-422B-B842-CB59AF35C2AD}" type="datetimeFigureOut">
              <a:rPr lang="en-US" smtClean="0"/>
              <a:pPr/>
              <a:t>6/20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D55BC0-53C9-48DE-A7A7-496C42709A0A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047232-3C14-422B-B842-CB59AF35C2AD}" type="datetimeFigureOut">
              <a:rPr lang="en-US" smtClean="0"/>
              <a:pPr/>
              <a:t>6/20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D55BC0-53C9-48DE-A7A7-496C42709A0A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047232-3C14-422B-B842-CB59AF35C2AD}" type="datetimeFigureOut">
              <a:rPr lang="en-US" smtClean="0"/>
              <a:pPr/>
              <a:t>6/20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D55BC0-53C9-48DE-A7A7-496C42709A0A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047232-3C14-422B-B842-CB59AF35C2AD}" type="datetimeFigureOut">
              <a:rPr lang="en-US" smtClean="0"/>
              <a:pPr/>
              <a:t>6/20/2016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D55BC0-53C9-48DE-A7A7-496C42709A0A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047232-3C14-422B-B842-CB59AF35C2AD}" type="datetimeFigureOut">
              <a:rPr lang="en-US" smtClean="0"/>
              <a:pPr/>
              <a:t>6/20/2016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D55BC0-53C9-48DE-A7A7-496C42709A0A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047232-3C14-422B-B842-CB59AF35C2AD}" type="datetimeFigureOut">
              <a:rPr lang="en-US" smtClean="0"/>
              <a:pPr/>
              <a:t>6/20/2016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D55BC0-53C9-48DE-A7A7-496C42709A0A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047232-3C14-422B-B842-CB59AF35C2AD}" type="datetimeFigureOut">
              <a:rPr lang="en-US" smtClean="0"/>
              <a:pPr/>
              <a:t>6/20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D55BC0-53C9-48DE-A7A7-496C42709A0A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047232-3C14-422B-B842-CB59AF35C2AD}" type="datetimeFigureOut">
              <a:rPr lang="en-US" smtClean="0"/>
              <a:pPr/>
              <a:t>6/20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D55BC0-53C9-48DE-A7A7-496C42709A0A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0047232-3C14-422B-B842-CB59AF35C2AD}" type="datetimeFigureOut">
              <a:rPr lang="en-US" smtClean="0"/>
              <a:pPr/>
              <a:t>6/20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2D55BC0-53C9-48DE-A7A7-496C42709A0A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3.png"/><Relationship Id="rId4" Type="http://schemas.openxmlformats.org/officeDocument/2006/relationships/image" Target="../media/image2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tiff"/><Relationship Id="rId7" Type="http://schemas.openxmlformats.org/officeDocument/2006/relationships/image" Target="../media/image9.tiff"/><Relationship Id="rId2" Type="http://schemas.openxmlformats.org/officeDocument/2006/relationships/image" Target="../media/image4.tif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8.tiff"/><Relationship Id="rId5" Type="http://schemas.openxmlformats.org/officeDocument/2006/relationships/image" Target="../media/image7.tiff"/><Relationship Id="rId4" Type="http://schemas.openxmlformats.org/officeDocument/2006/relationships/image" Target="../media/image6.tiff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15.jpeg"/><Relationship Id="rId3" Type="http://schemas.openxmlformats.org/officeDocument/2006/relationships/image" Target="../media/image10.jpeg"/><Relationship Id="rId7" Type="http://schemas.openxmlformats.org/officeDocument/2006/relationships/image" Target="../media/image14.jpe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3.jpeg"/><Relationship Id="rId11" Type="http://schemas.openxmlformats.org/officeDocument/2006/relationships/image" Target="../media/image18.jpeg"/><Relationship Id="rId5" Type="http://schemas.openxmlformats.org/officeDocument/2006/relationships/image" Target="../media/image12.jpeg"/><Relationship Id="rId10" Type="http://schemas.openxmlformats.org/officeDocument/2006/relationships/image" Target="../media/image17.jpeg"/><Relationship Id="rId4" Type="http://schemas.openxmlformats.org/officeDocument/2006/relationships/image" Target="../media/image11.jpeg"/><Relationship Id="rId9" Type="http://schemas.openxmlformats.org/officeDocument/2006/relationships/image" Target="../media/image16.jpe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81000" y="1981200"/>
            <a:ext cx="8229600" cy="1143000"/>
          </a:xfrm>
        </p:spPr>
        <p:txBody>
          <a:bodyPr/>
          <a:lstStyle/>
          <a:p>
            <a:r>
              <a:rPr lang="en-US" dirty="0">
                <a:latin typeface="Times New Roman" pitchFamily="18" charset="0"/>
                <a:cs typeface="Times New Roman" pitchFamily="18" charset="0"/>
              </a:rPr>
              <a:t>Supplementary Figures</a:t>
            </a:r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31" name="Group 130"/>
          <p:cNvGrpSpPr/>
          <p:nvPr/>
        </p:nvGrpSpPr>
        <p:grpSpPr>
          <a:xfrm>
            <a:off x="533400" y="2286000"/>
            <a:ext cx="8305800" cy="2667000"/>
            <a:chOff x="304800" y="685800"/>
            <a:chExt cx="8514936" cy="2286000"/>
          </a:xfrm>
        </p:grpSpPr>
        <p:pic>
          <p:nvPicPr>
            <p:cNvPr id="132" name="Picture 4"/>
            <p:cNvPicPr>
              <a:picLocks noChangeAspect="1" noChangeArrowheads="1"/>
            </p:cNvPicPr>
            <p:nvPr/>
          </p:nvPicPr>
          <p:blipFill>
            <a:blip r:embed="rId3" cstate="print"/>
            <a:srcRect/>
            <a:stretch>
              <a:fillRect/>
            </a:stretch>
          </p:blipFill>
          <p:spPr bwMode="auto">
            <a:xfrm>
              <a:off x="304800" y="685800"/>
              <a:ext cx="2876135" cy="22860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pic>
          <p:nvPicPr>
            <p:cNvPr id="133" name="Picture 5"/>
            <p:cNvPicPr>
              <a:picLocks noChangeAspect="1" noChangeArrowheads="1"/>
            </p:cNvPicPr>
            <p:nvPr/>
          </p:nvPicPr>
          <p:blipFill>
            <a:blip r:embed="rId4" cstate="print"/>
            <a:srcRect/>
            <a:stretch>
              <a:fillRect/>
            </a:stretch>
          </p:blipFill>
          <p:spPr bwMode="auto">
            <a:xfrm>
              <a:off x="3124200" y="685800"/>
              <a:ext cx="2883973" cy="22860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pic>
          <p:nvPicPr>
            <p:cNvPr id="134" name="Picture 6"/>
            <p:cNvPicPr>
              <a:picLocks noChangeAspect="1" noChangeArrowheads="1"/>
            </p:cNvPicPr>
            <p:nvPr/>
          </p:nvPicPr>
          <p:blipFill>
            <a:blip r:embed="rId5" cstate="print"/>
            <a:srcRect/>
            <a:stretch>
              <a:fillRect/>
            </a:stretch>
          </p:blipFill>
          <p:spPr bwMode="auto">
            <a:xfrm>
              <a:off x="5943600" y="685800"/>
              <a:ext cx="2876136" cy="22860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</p:grpSp>
      <p:sp>
        <p:nvSpPr>
          <p:cNvPr id="135" name="TextBox 134"/>
          <p:cNvSpPr txBox="1"/>
          <p:nvPr/>
        </p:nvSpPr>
        <p:spPr>
          <a:xfrm>
            <a:off x="533400" y="381000"/>
            <a:ext cx="231935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Supplemental Figure 1</a:t>
            </a:r>
          </a:p>
        </p:txBody>
      </p: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6172200" y="79765"/>
            <a:ext cx="231935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Supplemental Figure 2</a:t>
            </a:r>
          </a:p>
        </p:txBody>
      </p:sp>
      <p:sp>
        <p:nvSpPr>
          <p:cNvPr id="11" name="TextBox 10"/>
          <p:cNvSpPr txBox="1"/>
          <p:nvPr/>
        </p:nvSpPr>
        <p:spPr>
          <a:xfrm>
            <a:off x="2228850" y="728246"/>
            <a:ext cx="102870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OV 33</a:t>
            </a:r>
          </a:p>
        </p:txBody>
      </p:sp>
      <p:sp>
        <p:nvSpPr>
          <p:cNvPr id="12" name="TextBox 11"/>
          <p:cNvSpPr txBox="1"/>
          <p:nvPr/>
        </p:nvSpPr>
        <p:spPr>
          <a:xfrm>
            <a:off x="5826285" y="728246"/>
            <a:ext cx="102870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OV 4</a:t>
            </a:r>
          </a:p>
        </p:txBody>
      </p:sp>
      <p:pic>
        <p:nvPicPr>
          <p:cNvPr id="2" name="Picture 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219200" y="1066800"/>
            <a:ext cx="3035775" cy="3035775"/>
          </a:xfrm>
          <a:prstGeom prst="rect">
            <a:avLst/>
          </a:prstGeom>
        </p:spPr>
      </p:pic>
      <p:pic>
        <p:nvPicPr>
          <p:cNvPr id="3" name="Picture 2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804191" y="4267199"/>
            <a:ext cx="1450783" cy="1450783"/>
          </a:xfrm>
          <a:prstGeom prst="rect">
            <a:avLst/>
          </a:prstGeom>
        </p:spPr>
      </p:pic>
      <p:pic>
        <p:nvPicPr>
          <p:cNvPr id="13" name="Picture 12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219200" y="4267200"/>
            <a:ext cx="1445559" cy="1445559"/>
          </a:xfrm>
          <a:prstGeom prst="rect">
            <a:avLst/>
          </a:prstGeom>
        </p:spPr>
      </p:pic>
      <p:sp>
        <p:nvSpPr>
          <p:cNvPr id="14" name="TextBox 13"/>
          <p:cNvSpPr txBox="1"/>
          <p:nvPr/>
        </p:nvSpPr>
        <p:spPr>
          <a:xfrm>
            <a:off x="2804191" y="4267199"/>
            <a:ext cx="81678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ytokeratin</a:t>
            </a:r>
          </a:p>
        </p:txBody>
      </p:sp>
      <p:sp>
        <p:nvSpPr>
          <p:cNvPr id="15" name="TextBox 14"/>
          <p:cNvSpPr txBox="1"/>
          <p:nvPr/>
        </p:nvSpPr>
        <p:spPr>
          <a:xfrm>
            <a:off x="1219200" y="4267199"/>
            <a:ext cx="617717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DAPI</a:t>
            </a:r>
          </a:p>
        </p:txBody>
      </p:sp>
      <p:sp>
        <p:nvSpPr>
          <p:cNvPr id="16" name="TextBox 152"/>
          <p:cNvSpPr txBox="1">
            <a:spLocks noChangeArrowheads="1"/>
          </p:cNvSpPr>
          <p:nvPr/>
        </p:nvSpPr>
        <p:spPr bwMode="auto">
          <a:xfrm>
            <a:off x="1219200" y="1066799"/>
            <a:ext cx="914400" cy="33855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en-US" altLang="en-US" sz="1600" b="1" dirty="0">
                <a:solidFill>
                  <a:srgbClr val="CC00CC"/>
                </a:solidFill>
                <a:latin typeface="Times New Roman" pitchFamily="18" charset="0"/>
                <a:cs typeface="Times New Roman" pitchFamily="18" charset="0"/>
              </a:rPr>
              <a:t>CD20</a:t>
            </a:r>
          </a:p>
        </p:txBody>
      </p:sp>
      <p:pic>
        <p:nvPicPr>
          <p:cNvPr id="17" name="Picture 16"/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750568" y="1066799"/>
            <a:ext cx="3039164" cy="3039164"/>
          </a:xfrm>
          <a:prstGeom prst="rect">
            <a:avLst/>
          </a:prstGeom>
        </p:spPr>
      </p:pic>
      <p:pic>
        <p:nvPicPr>
          <p:cNvPr id="18" name="Picture 17"/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344332" y="4267199"/>
            <a:ext cx="1445400" cy="1445400"/>
          </a:xfrm>
          <a:prstGeom prst="rect">
            <a:avLst/>
          </a:prstGeom>
        </p:spPr>
      </p:pic>
      <p:pic>
        <p:nvPicPr>
          <p:cNvPr id="19" name="Picture 18"/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750568" y="4267199"/>
            <a:ext cx="1445400" cy="1445400"/>
          </a:xfrm>
          <a:prstGeom prst="rect">
            <a:avLst/>
          </a:prstGeom>
        </p:spPr>
      </p:pic>
      <p:sp>
        <p:nvSpPr>
          <p:cNvPr id="20" name="TextBox 19"/>
          <p:cNvSpPr txBox="1"/>
          <p:nvPr/>
        </p:nvSpPr>
        <p:spPr>
          <a:xfrm>
            <a:off x="6340783" y="4267199"/>
            <a:ext cx="81678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ytokeratin</a:t>
            </a:r>
          </a:p>
        </p:txBody>
      </p:sp>
      <p:sp>
        <p:nvSpPr>
          <p:cNvPr id="21" name="TextBox 20"/>
          <p:cNvSpPr txBox="1"/>
          <p:nvPr/>
        </p:nvSpPr>
        <p:spPr>
          <a:xfrm>
            <a:off x="4755792" y="4267199"/>
            <a:ext cx="617717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DAPI</a:t>
            </a:r>
          </a:p>
        </p:txBody>
      </p:sp>
      <p:sp>
        <p:nvSpPr>
          <p:cNvPr id="22" name="TextBox 152"/>
          <p:cNvSpPr txBox="1">
            <a:spLocks noChangeArrowheads="1"/>
          </p:cNvSpPr>
          <p:nvPr/>
        </p:nvSpPr>
        <p:spPr bwMode="auto">
          <a:xfrm>
            <a:off x="4755792" y="1066799"/>
            <a:ext cx="914400" cy="33855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en-US" altLang="en-US" sz="1600" b="1" dirty="0">
                <a:solidFill>
                  <a:srgbClr val="CC00CC"/>
                </a:solidFill>
                <a:latin typeface="Times New Roman" pitchFamily="18" charset="0"/>
                <a:cs typeface="Times New Roman" pitchFamily="18" charset="0"/>
              </a:rPr>
              <a:t>CD20</a:t>
            </a:r>
          </a:p>
        </p:txBody>
      </p:sp>
    </p:spTree>
    <p:extLst>
      <p:ext uri="{BB962C8B-B14F-4D97-AF65-F5344CB8AC3E}">
        <p14:creationId xmlns:p14="http://schemas.microsoft.com/office/powerpoint/2010/main" val="1794765089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141"/>
          <p:cNvSpPr txBox="1">
            <a:spLocks noChangeArrowheads="1"/>
          </p:cNvSpPr>
          <p:nvPr/>
        </p:nvSpPr>
        <p:spPr bwMode="auto">
          <a:xfrm>
            <a:off x="1829978" y="274267"/>
            <a:ext cx="914400" cy="4000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en-US" altLang="en-US" sz="2000" b="1" dirty="0">
                <a:latin typeface="Times New Roman" pitchFamily="18" charset="0"/>
                <a:cs typeface="Times New Roman" pitchFamily="18" charset="0"/>
              </a:rPr>
              <a:t>High</a:t>
            </a:r>
          </a:p>
        </p:txBody>
      </p:sp>
      <p:sp>
        <p:nvSpPr>
          <p:cNvPr id="5" name="TextBox 142"/>
          <p:cNvSpPr txBox="1">
            <a:spLocks noChangeArrowheads="1"/>
          </p:cNvSpPr>
          <p:nvPr/>
        </p:nvSpPr>
        <p:spPr bwMode="auto">
          <a:xfrm>
            <a:off x="3265195" y="279853"/>
            <a:ext cx="1828800" cy="4000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en-US" altLang="en-US" sz="2000" b="1" dirty="0">
                <a:latin typeface="Times New Roman" pitchFamily="18" charset="0"/>
                <a:cs typeface="Times New Roman" pitchFamily="18" charset="0"/>
              </a:rPr>
              <a:t>Intermediate</a:t>
            </a:r>
          </a:p>
        </p:txBody>
      </p:sp>
      <p:sp>
        <p:nvSpPr>
          <p:cNvPr id="6" name="TextBox 143"/>
          <p:cNvSpPr txBox="1">
            <a:spLocks noChangeArrowheads="1"/>
          </p:cNvSpPr>
          <p:nvPr/>
        </p:nvSpPr>
        <p:spPr bwMode="auto">
          <a:xfrm>
            <a:off x="5510782" y="279853"/>
            <a:ext cx="914400" cy="4000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en-US" altLang="en-US" sz="2000" b="1" dirty="0">
                <a:latin typeface="Times New Roman" pitchFamily="18" charset="0"/>
                <a:cs typeface="Times New Roman" pitchFamily="18" charset="0"/>
              </a:rPr>
              <a:t>Low</a:t>
            </a:r>
          </a:p>
        </p:txBody>
      </p:sp>
      <p:pic>
        <p:nvPicPr>
          <p:cNvPr id="7" name="Picture 144" descr="green CD8 spot 24.JPG"/>
          <p:cNvPicPr>
            <a:picLocks noChangeAspect="1"/>
          </p:cNvPicPr>
          <p:nvPr/>
        </p:nvPicPr>
        <p:blipFill>
          <a:blip r:embed="rId3" cstate="print"/>
          <a:srcRect/>
          <a:stretch>
            <a:fillRect/>
          </a:stretch>
        </p:blipFill>
        <p:spPr bwMode="auto">
          <a:xfrm>
            <a:off x="3192462" y="2524125"/>
            <a:ext cx="1706563" cy="170973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8" name="Picture 145" descr="green CD8 spot 36.JPG"/>
          <p:cNvPicPr>
            <a:picLocks noChangeAspect="1"/>
          </p:cNvPicPr>
          <p:nvPr/>
        </p:nvPicPr>
        <p:blipFill>
          <a:blip r:embed="rId4" cstate="print">
            <a:lum contrast="10000"/>
          </a:blip>
          <a:srcRect/>
          <a:stretch>
            <a:fillRect/>
          </a:stretch>
        </p:blipFill>
        <p:spPr bwMode="auto">
          <a:xfrm>
            <a:off x="5021262" y="2524125"/>
            <a:ext cx="1708150" cy="170973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9" name="Picture 146" descr="green CD8 spot 87.JPG"/>
          <p:cNvPicPr>
            <a:picLocks noChangeAspect="1"/>
          </p:cNvPicPr>
          <p:nvPr/>
        </p:nvPicPr>
        <p:blipFill>
          <a:blip r:embed="rId5" cstate="print"/>
          <a:srcRect/>
          <a:stretch>
            <a:fillRect/>
          </a:stretch>
        </p:blipFill>
        <p:spPr bwMode="auto">
          <a:xfrm>
            <a:off x="1363662" y="2524125"/>
            <a:ext cx="1709738" cy="170973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10" name="Picture 147" descr="magenta CD20 spot 17.JPG"/>
          <p:cNvPicPr>
            <a:picLocks noChangeAspect="1"/>
          </p:cNvPicPr>
          <p:nvPr/>
        </p:nvPicPr>
        <p:blipFill>
          <a:blip r:embed="rId6" cstate="print"/>
          <a:srcRect/>
          <a:stretch>
            <a:fillRect/>
          </a:stretch>
        </p:blipFill>
        <p:spPr bwMode="auto">
          <a:xfrm>
            <a:off x="1363662" y="4352925"/>
            <a:ext cx="1709738" cy="170973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11" name="Picture 148" descr="magenta CD20 spot 27.JPG"/>
          <p:cNvPicPr>
            <a:picLocks noChangeAspect="1"/>
          </p:cNvPicPr>
          <p:nvPr/>
        </p:nvPicPr>
        <p:blipFill>
          <a:blip r:embed="rId7" cstate="print"/>
          <a:srcRect/>
          <a:stretch>
            <a:fillRect/>
          </a:stretch>
        </p:blipFill>
        <p:spPr bwMode="auto">
          <a:xfrm>
            <a:off x="5029200" y="4343400"/>
            <a:ext cx="1716088" cy="170973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12" name="Picture 149" descr="magenta CD20 spot 40.JPG"/>
          <p:cNvPicPr>
            <a:picLocks noChangeAspect="1"/>
          </p:cNvPicPr>
          <p:nvPr/>
        </p:nvPicPr>
        <p:blipFill>
          <a:blip r:embed="rId8" cstate="print"/>
          <a:srcRect/>
          <a:stretch>
            <a:fillRect/>
          </a:stretch>
        </p:blipFill>
        <p:spPr bwMode="auto">
          <a:xfrm>
            <a:off x="3200400" y="4343400"/>
            <a:ext cx="1716088" cy="170973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13" name="TextBox 150"/>
          <p:cNvSpPr txBox="1">
            <a:spLocks noChangeArrowheads="1"/>
          </p:cNvSpPr>
          <p:nvPr/>
        </p:nvSpPr>
        <p:spPr bwMode="auto">
          <a:xfrm rot="16200000">
            <a:off x="692829" y="1296738"/>
            <a:ext cx="914400" cy="4000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en-US" altLang="en-US" sz="2000" b="1" dirty="0">
                <a:latin typeface="Times New Roman" pitchFamily="18" charset="0"/>
                <a:cs typeface="Times New Roman" pitchFamily="18" charset="0"/>
              </a:rPr>
              <a:t>CD3</a:t>
            </a:r>
          </a:p>
        </p:txBody>
      </p:sp>
      <p:sp>
        <p:nvSpPr>
          <p:cNvPr id="14" name="TextBox 151"/>
          <p:cNvSpPr txBox="1">
            <a:spLocks noChangeArrowheads="1"/>
          </p:cNvSpPr>
          <p:nvPr/>
        </p:nvSpPr>
        <p:spPr bwMode="auto">
          <a:xfrm rot="16200000">
            <a:off x="692829" y="3097704"/>
            <a:ext cx="914400" cy="4000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en-US" altLang="en-US" sz="2000" b="1" dirty="0">
                <a:latin typeface="Times New Roman" pitchFamily="18" charset="0"/>
                <a:cs typeface="Times New Roman" pitchFamily="18" charset="0"/>
              </a:rPr>
              <a:t>CD8</a:t>
            </a:r>
          </a:p>
        </p:txBody>
      </p:sp>
      <p:sp>
        <p:nvSpPr>
          <p:cNvPr id="15" name="TextBox 152"/>
          <p:cNvSpPr txBox="1">
            <a:spLocks noChangeArrowheads="1"/>
          </p:cNvSpPr>
          <p:nvPr/>
        </p:nvSpPr>
        <p:spPr bwMode="auto">
          <a:xfrm rot="16200000">
            <a:off x="692829" y="4960688"/>
            <a:ext cx="914400" cy="4000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en-US" altLang="en-US" sz="2000" b="1" dirty="0">
                <a:latin typeface="Times New Roman" pitchFamily="18" charset="0"/>
                <a:cs typeface="Times New Roman" pitchFamily="18" charset="0"/>
              </a:rPr>
              <a:t>CD20</a:t>
            </a:r>
          </a:p>
        </p:txBody>
      </p:sp>
      <p:pic>
        <p:nvPicPr>
          <p:cNvPr id="16" name="Picture 154" descr="CD3 red spot 7.JPG"/>
          <p:cNvPicPr>
            <a:picLocks noChangeAspect="1"/>
          </p:cNvPicPr>
          <p:nvPr/>
        </p:nvPicPr>
        <p:blipFill>
          <a:blip r:embed="rId9" cstate="print"/>
          <a:srcRect/>
          <a:stretch>
            <a:fillRect/>
          </a:stretch>
        </p:blipFill>
        <p:spPr bwMode="auto">
          <a:xfrm>
            <a:off x="1371600" y="685800"/>
            <a:ext cx="1709737" cy="170973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17" name="Picture 155" descr="CD3 red spot 12.JPG"/>
          <p:cNvPicPr>
            <a:picLocks noChangeAspect="1"/>
          </p:cNvPicPr>
          <p:nvPr/>
        </p:nvPicPr>
        <p:blipFill>
          <a:blip r:embed="rId10" cstate="print"/>
          <a:srcRect/>
          <a:stretch>
            <a:fillRect/>
          </a:stretch>
        </p:blipFill>
        <p:spPr bwMode="auto">
          <a:xfrm>
            <a:off x="3192462" y="695325"/>
            <a:ext cx="1709738" cy="170973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18" name="Picture 156" descr="CD3 red spot 43.JPG"/>
          <p:cNvPicPr>
            <a:picLocks noChangeAspect="1"/>
          </p:cNvPicPr>
          <p:nvPr/>
        </p:nvPicPr>
        <p:blipFill>
          <a:blip r:embed="rId11" cstate="print"/>
          <a:srcRect/>
          <a:stretch>
            <a:fillRect/>
          </a:stretch>
        </p:blipFill>
        <p:spPr bwMode="auto">
          <a:xfrm>
            <a:off x="5021262" y="695325"/>
            <a:ext cx="1703388" cy="170973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19" name="TextBox 18"/>
          <p:cNvSpPr txBox="1"/>
          <p:nvPr/>
        </p:nvSpPr>
        <p:spPr>
          <a:xfrm>
            <a:off x="6172200" y="79765"/>
            <a:ext cx="231935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Supplemental Figure 3</a:t>
            </a:r>
          </a:p>
        </p:txBody>
      </p:sp>
    </p:spTree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Chart 3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772611634"/>
              </p:ext>
            </p:extLst>
          </p:nvPr>
        </p:nvGraphicFramePr>
        <p:xfrm>
          <a:off x="685800" y="1752600"/>
          <a:ext cx="4024147" cy="343558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5" name="Chart 4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313787779"/>
              </p:ext>
            </p:extLst>
          </p:nvPr>
        </p:nvGraphicFramePr>
        <p:xfrm>
          <a:off x="4645612" y="1752599"/>
          <a:ext cx="4024147" cy="343558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6" name="TextBox 5"/>
          <p:cNvSpPr txBox="1"/>
          <p:nvPr/>
        </p:nvSpPr>
        <p:spPr>
          <a:xfrm>
            <a:off x="6172200" y="79765"/>
            <a:ext cx="233237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Supplemental </a:t>
            </a:r>
            <a:r>
              <a:rPr lang="en-US" b="1"/>
              <a:t>Figure 4</a:t>
            </a:r>
            <a:endParaRPr lang="en-US" b="1" dirty="0"/>
          </a:p>
        </p:txBody>
      </p:sp>
    </p:spTree>
    <p:extLst>
      <p:ext uri="{BB962C8B-B14F-4D97-AF65-F5344CB8AC3E}">
        <p14:creationId xmlns:p14="http://schemas.microsoft.com/office/powerpoint/2010/main" val="204057742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103</TotalTime>
  <Words>64</Words>
  <Application>Microsoft Office PowerPoint</Application>
  <PresentationFormat>On-screen Show (4:3)</PresentationFormat>
  <Paragraphs>29</Paragraphs>
  <Slides>5</Slides>
  <Notes>2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5</vt:i4>
      </vt:variant>
    </vt:vector>
  </HeadingPairs>
  <TitlesOfParts>
    <vt:vector size="9" baseType="lpstr">
      <vt:lpstr>Arial</vt:lpstr>
      <vt:lpstr>Calibri</vt:lpstr>
      <vt:lpstr>Times New Roman</vt:lpstr>
      <vt:lpstr>Office Theme</vt:lpstr>
      <vt:lpstr>Supplementary Figures</vt:lpstr>
      <vt:lpstr>PowerPoint Presentation</vt:lpstr>
      <vt:lpstr>PowerPoint Presentation</vt:lpstr>
      <vt:lpstr>PowerPoint Presentation</vt:lpstr>
      <vt:lpstr>PowerPoint Presentation</vt:lpstr>
    </vt:vector>
  </TitlesOfParts>
  <Company>Microsoft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RimmLab</dc:creator>
  <cp:lastModifiedBy>Rimm, David</cp:lastModifiedBy>
  <cp:revision>37</cp:revision>
  <dcterms:created xsi:type="dcterms:W3CDTF">2015-11-19T16:28:45Z</dcterms:created>
  <dcterms:modified xsi:type="dcterms:W3CDTF">2016-06-21T03:45:12Z</dcterms:modified>
</cp:coreProperties>
</file>